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2" r:id="rId3"/>
    <p:sldId id="263" r:id="rId4"/>
    <p:sldId id="264" r:id="rId5"/>
    <p:sldId id="261" r:id="rId6"/>
    <p:sldId id="260" r:id="rId7"/>
    <p:sldId id="259" r:id="rId8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3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3521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3723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3517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0269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0417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2644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9948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6102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8653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684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2394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4BE55-FEB7-4422-BE97-15975BBD99AB}" type="datetimeFigureOut">
              <a:rPr lang="ko-KR" altLang="en-US" smtClean="0"/>
              <a:t>2022-05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41FF2-60B0-4ADF-A6CA-02A0F47EFE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4423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7975" y="853108"/>
            <a:ext cx="6698577" cy="480060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4467038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6814" y="458154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= 0.110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828204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9844" y="848539"/>
            <a:ext cx="6698577" cy="480060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5990574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6814" y="458154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180172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9090" y="855740"/>
            <a:ext cx="6700085" cy="4797968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3731362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2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9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6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6814" y="458154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= 0.00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97187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6480" y="845917"/>
            <a:ext cx="6700085" cy="480406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1285953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14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r" defTabSz="914400" rtl="0" eaLnBrk="1" fontAlgn="ctr" latinLnBrk="1" hangingPunct="1"/>
                      <a:r>
                        <a:rPr lang="en-US" altLang="ko-KR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543638" y="4492470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= 0.03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983785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9090" y="857278"/>
            <a:ext cx="6700085" cy="4797968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6928973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6814" y="458154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= 0.36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99573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9090" y="855740"/>
            <a:ext cx="6700085" cy="4797968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7653460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6814" y="458154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= 0.01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314665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8271" y="846807"/>
            <a:ext cx="6700085" cy="480406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79512" y="135068"/>
            <a:ext cx="29803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2335711"/>
              </p:ext>
            </p:extLst>
          </p:nvPr>
        </p:nvGraphicFramePr>
        <p:xfrm>
          <a:off x="357239" y="5352633"/>
          <a:ext cx="8213310" cy="668655"/>
        </p:xfrm>
        <a:graphic>
          <a:graphicData uri="http://schemas.openxmlformats.org/drawingml/2006/table">
            <a:tbl>
              <a:tblPr/>
              <a:tblGrid>
                <a:gridCol w="1044000">
                  <a:extLst>
                    <a:ext uri="{9D8B030D-6E8A-4147-A177-3AD203B41FA5}">
                      <a16:colId xmlns:a16="http://schemas.microsoft.com/office/drawing/2014/main" val="1887076180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28073113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446138262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024032887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1128303599"/>
                    </a:ext>
                  </a:extLst>
                </a:gridCol>
                <a:gridCol w="1433862">
                  <a:extLst>
                    <a:ext uri="{9D8B030D-6E8A-4147-A177-3AD203B41FA5}">
                      <a16:colId xmlns:a16="http://schemas.microsoft.com/office/drawing/2014/main" val="2401251887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o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873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D-CCR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80561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orafeni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891525"/>
                  </a:ext>
                </a:extLst>
              </a:tr>
            </a:tbl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4669386" y="5139478"/>
            <a:ext cx="143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ime (months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0800000">
            <a:off x="2005142" y="2190886"/>
            <a:ext cx="461665" cy="18107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36814" y="458154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 = 0.027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071664" y="908720"/>
            <a:ext cx="1222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D-CCRT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071664" y="1253365"/>
            <a:ext cx="1334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orafeni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6372200" y="1093386"/>
            <a:ext cx="64216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6372200" y="1444524"/>
            <a:ext cx="642165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70310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203</Words>
  <Application>Microsoft Office PowerPoint</Application>
  <PresentationFormat>On-screen Show (4:3)</PresentationFormat>
  <Paragraphs>13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A957C1WDS092</dc:creator>
  <cp:lastModifiedBy>MDPI</cp:lastModifiedBy>
  <cp:revision>11</cp:revision>
  <dcterms:created xsi:type="dcterms:W3CDTF">2021-10-04T10:09:07Z</dcterms:created>
  <dcterms:modified xsi:type="dcterms:W3CDTF">2022-05-03T03:46:22Z</dcterms:modified>
</cp:coreProperties>
</file>